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01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w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4668-6CB4-4160-B1EA-ECECAC1CFC7B}" type="datetimeFigureOut">
              <a:rPr lang="it-IT" smtClean="0"/>
              <a:t>09/12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AE264-4EE1-47E5-9032-321A46A2126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030303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4668-6CB4-4160-B1EA-ECECAC1CFC7B}" type="datetimeFigureOut">
              <a:rPr lang="it-IT" smtClean="0"/>
              <a:t>09/12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AE264-4EE1-47E5-9032-321A46A2126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13797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4668-6CB4-4160-B1EA-ECECAC1CFC7B}" type="datetimeFigureOut">
              <a:rPr lang="it-IT" smtClean="0"/>
              <a:t>09/12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AE264-4EE1-47E5-9032-321A46A2126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25870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4668-6CB4-4160-B1EA-ECECAC1CFC7B}" type="datetimeFigureOut">
              <a:rPr lang="it-IT" smtClean="0"/>
              <a:t>09/12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AE264-4EE1-47E5-9032-321A46A2126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47798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4668-6CB4-4160-B1EA-ECECAC1CFC7B}" type="datetimeFigureOut">
              <a:rPr lang="it-IT" smtClean="0"/>
              <a:t>09/12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AE264-4EE1-47E5-9032-321A46A2126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15664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4668-6CB4-4160-B1EA-ECECAC1CFC7B}" type="datetimeFigureOut">
              <a:rPr lang="it-IT" smtClean="0"/>
              <a:t>09/12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AE264-4EE1-47E5-9032-321A46A2126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28218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4668-6CB4-4160-B1EA-ECECAC1CFC7B}" type="datetimeFigureOut">
              <a:rPr lang="it-IT" smtClean="0"/>
              <a:t>09/12/201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AE264-4EE1-47E5-9032-321A46A2126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6592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4668-6CB4-4160-B1EA-ECECAC1CFC7B}" type="datetimeFigureOut">
              <a:rPr lang="it-IT" smtClean="0"/>
              <a:t>09/12/201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AE264-4EE1-47E5-9032-321A46A2126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161656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4668-6CB4-4160-B1EA-ECECAC1CFC7B}" type="datetimeFigureOut">
              <a:rPr lang="it-IT" smtClean="0"/>
              <a:t>09/12/201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AE264-4EE1-47E5-9032-321A46A2126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849281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4668-6CB4-4160-B1EA-ECECAC1CFC7B}" type="datetimeFigureOut">
              <a:rPr lang="it-IT" smtClean="0"/>
              <a:t>09/12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AE264-4EE1-47E5-9032-321A46A2126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173005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94668-6CB4-4160-B1EA-ECECAC1CFC7B}" type="datetimeFigureOut">
              <a:rPr lang="it-IT" smtClean="0"/>
              <a:t>09/12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AE264-4EE1-47E5-9032-321A46A2126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710289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794668-6CB4-4160-B1EA-ECECAC1CFC7B}" type="datetimeFigureOut">
              <a:rPr lang="it-IT" smtClean="0"/>
              <a:t>09/12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0AE264-4EE1-47E5-9032-321A46A2126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579911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5"/>
          <p:cNvSpPr txBox="1">
            <a:spLocks noChangeArrowheads="1"/>
          </p:cNvSpPr>
          <p:nvPr/>
        </p:nvSpPr>
        <p:spPr bwMode="auto">
          <a:xfrm>
            <a:off x="188640" y="5652120"/>
            <a:ext cx="6570781" cy="26776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just" eaLnBrk="1" hangingPunct="1">
              <a:lnSpc>
                <a:spcPct val="200000"/>
              </a:lnSpc>
              <a:spcBef>
                <a:spcPct val="0"/>
              </a:spcBef>
              <a:buFontTx/>
              <a:buNone/>
            </a:pPr>
            <a:r>
              <a:rPr lang="it-IT" altLang="it-IT" sz="1200" b="1" dirty="0" err="1">
                <a:latin typeface="Times New Roman" pitchFamily="18" charset="0"/>
                <a:cs typeface="Times New Roman" pitchFamily="18" charset="0"/>
              </a:rPr>
              <a:t>Additional</a:t>
            </a:r>
            <a:r>
              <a:rPr lang="it-IT" altLang="it-IT" sz="1200" b="1" dirty="0">
                <a:latin typeface="Times New Roman" pitchFamily="18" charset="0"/>
                <a:cs typeface="Times New Roman" pitchFamily="18" charset="0"/>
              </a:rPr>
              <a:t> file </a:t>
            </a:r>
            <a:r>
              <a:rPr lang="it-IT" altLang="it-IT" sz="1200" b="1" dirty="0" smtClean="0">
                <a:latin typeface="Times New Roman" pitchFamily="18" charset="0"/>
                <a:cs typeface="Times New Roman" pitchFamily="18" charset="0"/>
              </a:rPr>
              <a:t>3: Figure S3</a:t>
            </a:r>
            <a:r>
              <a:rPr lang="it-IT" altLang="it-IT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it-IT" sz="1200" dirty="0">
                <a:latin typeface="Times New Roman" pitchFamily="18" charset="0"/>
                <a:cs typeface="Times New Roman" pitchFamily="18" charset="0"/>
              </a:rPr>
              <a:t>Flow cytometry </a:t>
            </a:r>
            <a:r>
              <a:rPr lang="en-US" altLang="it-IT" sz="1200" dirty="0" err="1">
                <a:latin typeface="Times New Roman" pitchFamily="18" charset="0"/>
                <a:cs typeface="Times New Roman" pitchFamily="18" charset="0"/>
              </a:rPr>
              <a:t>immunophenotyping</a:t>
            </a:r>
            <a:r>
              <a:rPr lang="en-US" altLang="it-IT" sz="1200" dirty="0">
                <a:latin typeface="Times New Roman" pitchFamily="18" charset="0"/>
                <a:cs typeface="Times New Roman" pitchFamily="18" charset="0"/>
              </a:rPr>
              <a:t> of DPN-treated T lymphocytes. Flow cytometry analysis of  cytokine expression at the single cell </a:t>
            </a:r>
            <a:r>
              <a:rPr lang="en-US" altLang="it-IT" sz="1200" dirty="0" smtClean="0">
                <a:latin typeface="Times New Roman" pitchFamily="18" charset="0"/>
                <a:cs typeface="Times New Roman" pitchFamily="18" charset="0"/>
              </a:rPr>
              <a:t>level was </a:t>
            </a:r>
            <a:r>
              <a:rPr lang="en-US" altLang="it-IT" sz="1200" dirty="0">
                <a:latin typeface="Times New Roman" pitchFamily="18" charset="0"/>
                <a:cs typeface="Times New Roman" pitchFamily="18" charset="0"/>
              </a:rPr>
              <a:t>carried out in CD4</a:t>
            </a:r>
            <a:r>
              <a:rPr lang="en-US" altLang="it-IT" sz="12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altLang="it-IT" sz="1200" dirty="0">
                <a:latin typeface="Times New Roman" pitchFamily="18" charset="0"/>
                <a:cs typeface="Times New Roman" pitchFamily="18" charset="0"/>
              </a:rPr>
              <a:t> and CD8</a:t>
            </a:r>
            <a:r>
              <a:rPr lang="en-US" altLang="it-IT" sz="12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altLang="it-IT" sz="1200" dirty="0">
                <a:latin typeface="Times New Roman" pitchFamily="18" charset="0"/>
                <a:cs typeface="Times New Roman" pitchFamily="18" charset="0"/>
              </a:rPr>
              <a:t> T lymphocytes from randomly selected SLE patients with SLEDAI-2K &lt; 6 and ≥ 6 (</a:t>
            </a:r>
            <a:r>
              <a:rPr lang="en-US" altLang="it-IT" sz="1200" i="1" dirty="0">
                <a:latin typeface="Times New Roman" pitchFamily="18" charset="0"/>
                <a:cs typeface="Times New Roman" pitchFamily="18" charset="0"/>
              </a:rPr>
              <a:t>n</a:t>
            </a:r>
            <a:r>
              <a:rPr lang="en-US" altLang="it-IT" sz="1200" dirty="0">
                <a:latin typeface="Times New Roman" pitchFamily="18" charset="0"/>
                <a:cs typeface="Times New Roman" pitchFamily="18" charset="0"/>
              </a:rPr>
              <a:t> = 5 for group), arbitrarily chosen as representative of the whole series, and treated with DPN (10 </a:t>
            </a:r>
            <a:r>
              <a:rPr lang="en-US" altLang="it-IT" sz="1200" dirty="0" err="1">
                <a:latin typeface="Times New Roman" pitchFamily="18" charset="0"/>
                <a:cs typeface="Times New Roman" pitchFamily="18" charset="0"/>
              </a:rPr>
              <a:t>nM</a:t>
            </a:r>
            <a:r>
              <a:rPr lang="en-US" altLang="it-IT" sz="1200" dirty="0">
                <a:latin typeface="Times New Roman" pitchFamily="18" charset="0"/>
                <a:cs typeface="Times New Roman" pitchFamily="18" charset="0"/>
              </a:rPr>
              <a:t>) for 48 hours. For CD4</a:t>
            </a:r>
            <a:r>
              <a:rPr lang="en-US" altLang="it-IT" sz="12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altLang="it-IT" sz="1200" dirty="0">
                <a:latin typeface="Times New Roman" pitchFamily="18" charset="0"/>
                <a:cs typeface="Times New Roman" pitchFamily="18" charset="0"/>
              </a:rPr>
              <a:t> and CD8</a:t>
            </a:r>
            <a:r>
              <a:rPr lang="en-US" altLang="it-IT" sz="12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altLang="it-IT" sz="1200" dirty="0">
                <a:latin typeface="Times New Roman" pitchFamily="18" charset="0"/>
                <a:cs typeface="Times New Roman" pitchFamily="18" charset="0"/>
              </a:rPr>
              <a:t> T lymphocyte subsets, data were expressed as the percentage of each subset within the CD4</a:t>
            </a:r>
            <a:r>
              <a:rPr lang="en-US" altLang="it-IT" sz="12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altLang="it-IT" sz="1200" dirty="0">
                <a:latin typeface="Times New Roman" pitchFamily="18" charset="0"/>
                <a:cs typeface="Times New Roman" pitchFamily="18" charset="0"/>
              </a:rPr>
              <a:t> or CD8</a:t>
            </a:r>
            <a:r>
              <a:rPr lang="en-US" altLang="it-IT" sz="12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altLang="it-IT" sz="1200" dirty="0">
                <a:latin typeface="Times New Roman" pitchFamily="18" charset="0"/>
                <a:cs typeface="Times New Roman" pitchFamily="18" charset="0"/>
              </a:rPr>
              <a:t> population considered as 100%. Data are represented as box plots displaying medians, 25th and 75th percentiles as boxes, and the lowest and highest values as whiskers. </a:t>
            </a:r>
            <a:endParaRPr lang="it-IT" altLang="it-IT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CasellaDiTesto 32"/>
          <p:cNvSpPr txBox="1"/>
          <p:nvPr/>
        </p:nvSpPr>
        <p:spPr>
          <a:xfrm>
            <a:off x="6047166" y="8848757"/>
            <a:ext cx="7873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3" name="Gruppo 42"/>
          <p:cNvGrpSpPr/>
          <p:nvPr/>
        </p:nvGrpSpPr>
        <p:grpSpPr>
          <a:xfrm>
            <a:off x="128315" y="323528"/>
            <a:ext cx="6618385" cy="5184576"/>
            <a:chOff x="128315" y="323528"/>
            <a:chExt cx="6618385" cy="5184576"/>
          </a:xfrm>
        </p:grpSpPr>
        <p:grpSp>
          <p:nvGrpSpPr>
            <p:cNvPr id="41" name="Gruppo 40"/>
            <p:cNvGrpSpPr/>
            <p:nvPr/>
          </p:nvGrpSpPr>
          <p:grpSpPr>
            <a:xfrm>
              <a:off x="5589240" y="323528"/>
              <a:ext cx="865882" cy="385191"/>
              <a:chOff x="5854278" y="107504"/>
              <a:chExt cx="865882" cy="385191"/>
            </a:xfrm>
          </p:grpSpPr>
          <p:sp>
            <p:nvSpPr>
              <p:cNvPr id="14" name="Text Box 194"/>
              <p:cNvSpPr txBox="1">
                <a:spLocks noChangeArrowheads="1"/>
              </p:cNvSpPr>
              <p:nvPr/>
            </p:nvSpPr>
            <p:spPr bwMode="auto">
              <a:xfrm>
                <a:off x="5953589" y="246474"/>
                <a:ext cx="455574" cy="246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it-IT" altLang="it-IT" sz="1000" b="1" dirty="0" smtClean="0">
                    <a:sym typeface="Symbol" pitchFamily="18" charset="2"/>
                  </a:rPr>
                  <a:t>DPN</a:t>
                </a:r>
                <a:endParaRPr lang="it-IT" altLang="it-IT" sz="1000" b="1" dirty="0">
                  <a:sym typeface="Symbol" pitchFamily="18" charset="2"/>
                </a:endParaRPr>
              </a:p>
            </p:txBody>
          </p:sp>
          <p:sp>
            <p:nvSpPr>
              <p:cNvPr id="15" name="Text Box 195"/>
              <p:cNvSpPr txBox="1">
                <a:spLocks noChangeArrowheads="1"/>
              </p:cNvSpPr>
              <p:nvPr/>
            </p:nvSpPr>
            <p:spPr bwMode="auto">
              <a:xfrm>
                <a:off x="5952001" y="107504"/>
                <a:ext cx="768159" cy="246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it-IT" altLang="it-IT" sz="1000" b="1" dirty="0" err="1"/>
                  <a:t>untreated</a:t>
                </a:r>
                <a:endParaRPr lang="it-IT" altLang="it-IT" sz="1000" b="1" dirty="0"/>
              </a:p>
            </p:txBody>
          </p:sp>
          <p:grpSp>
            <p:nvGrpSpPr>
              <p:cNvPr id="16" name="Gruppo 15"/>
              <p:cNvGrpSpPr/>
              <p:nvPr/>
            </p:nvGrpSpPr>
            <p:grpSpPr>
              <a:xfrm>
                <a:off x="5854278" y="207917"/>
                <a:ext cx="117475" cy="185738"/>
                <a:chOff x="5662613" y="2925763"/>
                <a:chExt cx="117475" cy="185738"/>
              </a:xfrm>
            </p:grpSpPr>
            <p:sp>
              <p:nvSpPr>
                <p:cNvPr id="27" name="Rectangle 72"/>
                <p:cNvSpPr>
                  <a:spLocks noChangeArrowheads="1"/>
                </p:cNvSpPr>
                <p:nvPr/>
              </p:nvSpPr>
              <p:spPr bwMode="auto">
                <a:xfrm>
                  <a:off x="5662613" y="2925763"/>
                  <a:ext cx="117475" cy="60325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28" name="Freeform 73"/>
                <p:cNvSpPr>
                  <a:spLocks/>
                </p:cNvSpPr>
                <p:nvPr/>
              </p:nvSpPr>
              <p:spPr bwMode="auto">
                <a:xfrm>
                  <a:off x="5662613" y="2925763"/>
                  <a:ext cx="117475" cy="60325"/>
                </a:xfrm>
                <a:custGeom>
                  <a:avLst/>
                  <a:gdLst>
                    <a:gd name="T0" fmla="*/ 0 w 128"/>
                    <a:gd name="T1" fmla="*/ 0 h 66"/>
                    <a:gd name="T2" fmla="*/ 0 w 128"/>
                    <a:gd name="T3" fmla="*/ 0 h 66"/>
                    <a:gd name="T4" fmla="*/ 128 w 128"/>
                    <a:gd name="T5" fmla="*/ 0 h 66"/>
                    <a:gd name="T6" fmla="*/ 128 w 128"/>
                    <a:gd name="T7" fmla="*/ 66 h 66"/>
                    <a:gd name="T8" fmla="*/ 0 w 128"/>
                    <a:gd name="T9" fmla="*/ 66 h 66"/>
                    <a:gd name="T10" fmla="*/ 0 w 128"/>
                    <a:gd name="T11" fmla="*/ 0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28" h="66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28" y="0"/>
                      </a:lnTo>
                      <a:lnTo>
                        <a:pt x="128" y="66"/>
                      </a:lnTo>
                      <a:lnTo>
                        <a:pt x="0" y="66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29" name="Rectangle 74"/>
                <p:cNvSpPr>
                  <a:spLocks noChangeArrowheads="1"/>
                </p:cNvSpPr>
                <p:nvPr/>
              </p:nvSpPr>
              <p:spPr bwMode="auto">
                <a:xfrm>
                  <a:off x="5662613" y="3051176"/>
                  <a:ext cx="117475" cy="60325"/>
                </a:xfrm>
                <a:prstGeom prst="rect">
                  <a:avLst/>
                </a:prstGeom>
                <a:solidFill>
                  <a:srgbClr val="A0A0A4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0" name="Freeform 75"/>
                <p:cNvSpPr>
                  <a:spLocks/>
                </p:cNvSpPr>
                <p:nvPr/>
              </p:nvSpPr>
              <p:spPr bwMode="auto">
                <a:xfrm>
                  <a:off x="5662613" y="3051176"/>
                  <a:ext cx="117475" cy="60325"/>
                </a:xfrm>
                <a:custGeom>
                  <a:avLst/>
                  <a:gdLst>
                    <a:gd name="T0" fmla="*/ 0 w 128"/>
                    <a:gd name="T1" fmla="*/ 0 h 66"/>
                    <a:gd name="T2" fmla="*/ 0 w 128"/>
                    <a:gd name="T3" fmla="*/ 0 h 66"/>
                    <a:gd name="T4" fmla="*/ 128 w 128"/>
                    <a:gd name="T5" fmla="*/ 0 h 66"/>
                    <a:gd name="T6" fmla="*/ 128 w 128"/>
                    <a:gd name="T7" fmla="*/ 66 h 66"/>
                    <a:gd name="T8" fmla="*/ 0 w 128"/>
                    <a:gd name="T9" fmla="*/ 66 h 66"/>
                    <a:gd name="T10" fmla="*/ 0 w 128"/>
                    <a:gd name="T11" fmla="*/ 0 h 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28" h="66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28" y="0"/>
                      </a:lnTo>
                      <a:lnTo>
                        <a:pt x="128" y="66"/>
                      </a:lnTo>
                      <a:lnTo>
                        <a:pt x="0" y="66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11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</p:grpSp>
        </p:grpSp>
        <p:grpSp>
          <p:nvGrpSpPr>
            <p:cNvPr id="40" name="Gruppo 39"/>
            <p:cNvGrpSpPr/>
            <p:nvPr/>
          </p:nvGrpSpPr>
          <p:grpSpPr>
            <a:xfrm>
              <a:off x="128315" y="3227388"/>
              <a:ext cx="2746648" cy="2280716"/>
              <a:chOff x="119325" y="3030840"/>
              <a:chExt cx="2746648" cy="2280716"/>
            </a:xfrm>
          </p:grpSpPr>
          <p:grpSp>
            <p:nvGrpSpPr>
              <p:cNvPr id="9" name="Gruppo 8"/>
              <p:cNvGrpSpPr/>
              <p:nvPr/>
            </p:nvGrpSpPr>
            <p:grpSpPr>
              <a:xfrm>
                <a:off x="119325" y="3030840"/>
                <a:ext cx="2746648" cy="1757362"/>
                <a:chOff x="4443555" y="4755557"/>
                <a:chExt cx="2746648" cy="1757362"/>
              </a:xfrm>
            </p:grpSpPr>
            <p:graphicFrame>
              <p:nvGraphicFramePr>
                <p:cNvPr id="34" name="Oggetto 33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817328606"/>
                    </p:ext>
                  </p:extLst>
                </p:nvPr>
              </p:nvGraphicFramePr>
              <p:xfrm>
                <a:off x="4627978" y="4755557"/>
                <a:ext cx="2562225" cy="1757362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098" name="Prism Project" r:id="rId3" imgW="3204000" imgH="2196000" progId="Prism5.Document">
                        <p:embed/>
                      </p:oleObj>
                    </mc:Choice>
                    <mc:Fallback>
                      <p:oleObj name="Prism Project" r:id="rId3" imgW="3204000" imgH="2196000" progId="Prism5.Document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4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627978" y="4755557"/>
                              <a:ext cx="2562225" cy="1757362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35" name="CasellaDiTesto 34"/>
                <p:cNvSpPr txBox="1"/>
                <p:nvPr/>
              </p:nvSpPr>
              <p:spPr>
                <a:xfrm rot="16200000">
                  <a:off x="3839544" y="5565100"/>
                  <a:ext cx="145424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% CD4</a:t>
                  </a:r>
                  <a:r>
                    <a:rPr lang="it-IT" sz="1000" b="1" baseline="30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it-IT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/IL-17</a:t>
                  </a:r>
                  <a:r>
                    <a:rPr lang="it-IT" sz="1000" b="1" baseline="30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it-IT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T </a:t>
                  </a:r>
                  <a:r>
                    <a:rPr lang="it-IT" sz="1000" b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ells</a:t>
                  </a:r>
                  <a:endParaRPr lang="it-IT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5" name="CasellaDiTesto 24"/>
              <p:cNvSpPr txBox="1"/>
              <p:nvPr/>
            </p:nvSpPr>
            <p:spPr>
              <a:xfrm rot="18600000">
                <a:off x="654101" y="4863677"/>
                <a:ext cx="64953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LE &lt; 6</a:t>
                </a:r>
                <a:endParaRPr lang="it-IT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CasellaDiTesto 25"/>
              <p:cNvSpPr txBox="1"/>
              <p:nvPr/>
            </p:nvSpPr>
            <p:spPr>
              <a:xfrm rot="18600000">
                <a:off x="1826720" y="4861835"/>
                <a:ext cx="64472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LE ≥ 6</a:t>
                </a:r>
                <a:endParaRPr lang="it-IT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2" name="Gruppo 31"/>
            <p:cNvGrpSpPr/>
            <p:nvPr/>
          </p:nvGrpSpPr>
          <p:grpSpPr>
            <a:xfrm>
              <a:off x="136823" y="828675"/>
              <a:ext cx="6609877" cy="2268718"/>
              <a:chOff x="136823" y="828675"/>
              <a:chExt cx="6609877" cy="2268718"/>
            </a:xfrm>
          </p:grpSpPr>
          <p:grpSp>
            <p:nvGrpSpPr>
              <p:cNvPr id="38" name="Gruppo 37"/>
              <p:cNvGrpSpPr/>
              <p:nvPr/>
            </p:nvGrpSpPr>
            <p:grpSpPr>
              <a:xfrm>
                <a:off x="136823" y="828675"/>
                <a:ext cx="3174166" cy="2263228"/>
                <a:chOff x="3502149" y="324619"/>
                <a:chExt cx="3174166" cy="2263228"/>
              </a:xfrm>
            </p:grpSpPr>
            <p:sp>
              <p:nvSpPr>
                <p:cNvPr id="10" name="CasellaDiTesto 9"/>
                <p:cNvSpPr txBox="1"/>
                <p:nvPr/>
              </p:nvSpPr>
              <p:spPr>
                <a:xfrm rot="16200000">
                  <a:off x="2886917" y="1146277"/>
                  <a:ext cx="147668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% CD4</a:t>
                  </a:r>
                  <a:r>
                    <a:rPr lang="it-IT" sz="1000" b="1" baseline="30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it-IT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/IFN-</a:t>
                  </a:r>
                  <a:r>
                    <a:rPr lang="el-G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γ</a:t>
                  </a:r>
                  <a:r>
                    <a:rPr lang="it-IT" sz="1000" b="1" baseline="30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it-IT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T </a:t>
                  </a:r>
                  <a:r>
                    <a:rPr lang="it-IT" sz="1000" b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ells</a:t>
                  </a:r>
                  <a:endParaRPr lang="it-IT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CasellaDiTesto 10"/>
                <p:cNvSpPr txBox="1"/>
                <p:nvPr/>
              </p:nvSpPr>
              <p:spPr>
                <a:xfrm rot="5400000">
                  <a:off x="5814862" y="1152627"/>
                  <a:ext cx="147668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% CD8</a:t>
                  </a:r>
                  <a:r>
                    <a:rPr lang="it-IT" sz="1000" b="1" baseline="30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it-IT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/IFN-</a:t>
                  </a:r>
                  <a:r>
                    <a:rPr lang="el-G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γ</a:t>
                  </a:r>
                  <a:r>
                    <a:rPr lang="it-IT" sz="1000" b="1" baseline="30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it-IT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T </a:t>
                  </a:r>
                  <a:r>
                    <a:rPr lang="it-IT" sz="1000" b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ells</a:t>
                  </a:r>
                  <a:endParaRPr lang="it-IT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aphicFrame>
              <p:nvGraphicFramePr>
                <p:cNvPr id="13" name="Oggetto 12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479644430"/>
                    </p:ext>
                  </p:extLst>
                </p:nvPr>
              </p:nvGraphicFramePr>
              <p:xfrm>
                <a:off x="3703464" y="324619"/>
                <a:ext cx="2782887" cy="176371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099" name="Prism Project" r:id="rId5" imgW="3476160" imgH="2206440" progId="Prism5.Document">
                        <p:embed/>
                      </p:oleObj>
                    </mc:Choice>
                    <mc:Fallback>
                      <p:oleObj name="Prism Project" r:id="rId5" imgW="3476160" imgH="2206440" progId="Prism5.Document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6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703464" y="324619"/>
                              <a:ext cx="2782887" cy="176371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21" name="CasellaDiTesto 20"/>
                <p:cNvSpPr txBox="1"/>
                <p:nvPr/>
              </p:nvSpPr>
              <p:spPr>
                <a:xfrm rot="18600000">
                  <a:off x="3771653" y="2139538"/>
                  <a:ext cx="64953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LE &lt; 6</a:t>
                  </a:r>
                  <a:endParaRPr lang="it-IT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CasellaDiTesto 21"/>
                <p:cNvSpPr txBox="1"/>
                <p:nvPr/>
              </p:nvSpPr>
              <p:spPr>
                <a:xfrm rot="18600000">
                  <a:off x="4265353" y="2139383"/>
                  <a:ext cx="64472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LE ≥ 6</a:t>
                  </a:r>
                  <a:endParaRPr lang="it-IT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CasellaDiTesto 22"/>
                <p:cNvSpPr txBox="1"/>
                <p:nvPr/>
              </p:nvSpPr>
              <p:spPr>
                <a:xfrm rot="18600000">
                  <a:off x="4974581" y="2139968"/>
                  <a:ext cx="64953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LE &lt; 6</a:t>
                  </a:r>
                  <a:endParaRPr lang="it-IT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CasellaDiTesto 23"/>
                <p:cNvSpPr txBox="1"/>
                <p:nvPr/>
              </p:nvSpPr>
              <p:spPr>
                <a:xfrm rot="18600000">
                  <a:off x="5467378" y="2133463"/>
                  <a:ext cx="64472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LE ≥ 6</a:t>
                  </a:r>
                  <a:endParaRPr lang="it-IT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8" name="Gruppo 7"/>
              <p:cNvGrpSpPr/>
              <p:nvPr/>
            </p:nvGrpSpPr>
            <p:grpSpPr>
              <a:xfrm>
                <a:off x="3501008" y="833438"/>
                <a:ext cx="3245692" cy="2263955"/>
                <a:chOff x="214040" y="323032"/>
                <a:chExt cx="3245692" cy="2263955"/>
              </a:xfrm>
            </p:grpSpPr>
            <p:grpSp>
              <p:nvGrpSpPr>
                <p:cNvPr id="12" name="Gruppo 11"/>
                <p:cNvGrpSpPr/>
                <p:nvPr/>
              </p:nvGrpSpPr>
              <p:grpSpPr>
                <a:xfrm>
                  <a:off x="214040" y="569145"/>
                  <a:ext cx="3245692" cy="1388028"/>
                  <a:chOff x="2742009" y="5784205"/>
                  <a:chExt cx="3245692" cy="1388028"/>
                </a:xfrm>
              </p:grpSpPr>
              <p:sp>
                <p:nvSpPr>
                  <p:cNvPr id="33" name="CasellaDiTesto 32"/>
                  <p:cNvSpPr txBox="1"/>
                  <p:nvPr/>
                </p:nvSpPr>
                <p:spPr>
                  <a:xfrm rot="5400000">
                    <a:off x="5172735" y="6352950"/>
                    <a:ext cx="13837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% </a:t>
                    </a:r>
                    <a:r>
                      <a:rPr lang="it-IT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8</a:t>
                    </a:r>
                    <a:r>
                      <a:rPr lang="it-IT" sz="1000" b="1" baseline="30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r>
                      <a:rPr lang="it-IT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/IL-4</a:t>
                    </a:r>
                    <a:r>
                      <a:rPr lang="it-IT" sz="1000" b="1" baseline="30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r>
                      <a:rPr lang="it-IT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T </a:t>
                    </a:r>
                    <a:r>
                      <a:rPr lang="it-IT" sz="1000" b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ells</a:t>
                    </a:r>
                    <a:endParaRPr lang="it-IT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" name="CasellaDiTesto 30"/>
                  <p:cNvSpPr txBox="1"/>
                  <p:nvPr/>
                </p:nvSpPr>
                <p:spPr>
                  <a:xfrm rot="16200000">
                    <a:off x="2173264" y="6357266"/>
                    <a:ext cx="138371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% CD4</a:t>
                    </a:r>
                    <a:r>
                      <a:rPr lang="it-IT" sz="1000" b="1" baseline="30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r>
                      <a:rPr lang="it-IT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/IL-4</a:t>
                    </a:r>
                    <a:r>
                      <a:rPr lang="it-IT" sz="1000" b="1" baseline="30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r>
                      <a:rPr lang="it-IT" sz="10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T </a:t>
                    </a:r>
                    <a:r>
                      <a:rPr lang="it-IT" sz="1000" b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ells</a:t>
                    </a:r>
                    <a:endParaRPr lang="it-IT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7" name="CasellaDiTesto 16"/>
                <p:cNvSpPr txBox="1"/>
                <p:nvPr/>
              </p:nvSpPr>
              <p:spPr>
                <a:xfrm rot="18600000">
                  <a:off x="520627" y="2138678"/>
                  <a:ext cx="64953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LE &lt; 6</a:t>
                  </a:r>
                  <a:endParaRPr lang="it-IT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CasellaDiTesto 17"/>
                <p:cNvSpPr txBox="1"/>
                <p:nvPr/>
              </p:nvSpPr>
              <p:spPr>
                <a:xfrm rot="18600000">
                  <a:off x="1013424" y="2136073"/>
                  <a:ext cx="64472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LE ≥ 6</a:t>
                  </a:r>
                  <a:endParaRPr lang="it-IT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CasellaDiTesto 18"/>
                <p:cNvSpPr txBox="1"/>
                <p:nvPr/>
              </p:nvSpPr>
              <p:spPr>
                <a:xfrm rot="18600000">
                  <a:off x="1735904" y="2139108"/>
                  <a:ext cx="64953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LE &lt; 6</a:t>
                  </a:r>
                  <a:endParaRPr lang="it-IT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CasellaDiTesto 19"/>
                <p:cNvSpPr txBox="1"/>
                <p:nvPr/>
              </p:nvSpPr>
              <p:spPr>
                <a:xfrm rot="18600000">
                  <a:off x="2229052" y="2138953"/>
                  <a:ext cx="64472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LE ≥ 6</a:t>
                  </a:r>
                  <a:endParaRPr lang="it-IT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7" name="Connettore 1 36"/>
                <p:cNvCxnSpPr/>
                <p:nvPr/>
              </p:nvCxnSpPr>
              <p:spPr>
                <a:xfrm>
                  <a:off x="592182" y="2048291"/>
                  <a:ext cx="0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aphicFrame>
              <p:nvGraphicFramePr>
                <p:cNvPr id="36" name="Oggetto 35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535700649"/>
                    </p:ext>
                  </p:extLst>
                </p:nvPr>
              </p:nvGraphicFramePr>
              <p:xfrm>
                <a:off x="427782" y="323032"/>
                <a:ext cx="2851150" cy="1757362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100" name="Prism Project" r:id="rId7" imgW="3564000" imgH="2196000" progId="Prism5.Document">
                        <p:embed/>
                      </p:oleObj>
                    </mc:Choice>
                    <mc:Fallback>
                      <p:oleObj name="Prism Project" r:id="rId7" imgW="3564000" imgH="2196000" progId="Prism5.Document">
                        <p:embed/>
                        <p:pic>
                          <p:nvPicPr>
                            <p:cNvPr id="0" name=""/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>
                            <a:blip r:embed="rId8"/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427782" y="323032"/>
                              <a:ext cx="2851150" cy="1757362"/>
                            </a:xfrm>
                            <a:prstGeom prst="rect">
                              <a:avLst/>
                            </a:prstGeom>
                            <a:noFill/>
                            <a:ln>
                              <a:noFill/>
                            </a:ln>
                            <a:extLst>
                              <a:ext uri="{909E8E84-426E-40DD-AFC4-6F175D3DCCD1}">
                                <a14:hiddenFill xmlns:a14="http://schemas.microsoft.com/office/drawing/2010/main">
                                  <a:solidFill>
                                    <a:srgbClr val="FFFFFF"/>
                                  </a:solidFill>
                                </a14:hiddenFill>
                              </a:ext>
                              <a:ext uri="{91240B29-F687-4F45-9708-019B960494DF}">
                                <a14:hiddenLine xmlns:a14="http://schemas.microsoft.com/office/drawing/2010/main" w="9525">
                                  <a:solidFill>
                                    <a:srgbClr val="000000"/>
                                  </a:solidFill>
                                  <a:miter lim="800000"/>
                                  <a:headEnd/>
                                  <a:tailEnd/>
                                </a14:hiddenLine>
                              </a:ext>
                            </a:extLst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</p:grpSp>
      </p:grpSp>
    </p:spTree>
    <p:extLst>
      <p:ext uri="{BB962C8B-B14F-4D97-AF65-F5344CB8AC3E}">
        <p14:creationId xmlns:p14="http://schemas.microsoft.com/office/powerpoint/2010/main" val="332215446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7</TotalTime>
  <Words>204</Words>
  <Application>Microsoft Office PowerPoint</Application>
  <PresentationFormat>Presentazione su schermo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er OLE incorporati</vt:lpstr>
      </vt:variant>
      <vt:variant>
        <vt:i4>2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Tema di Office</vt:lpstr>
      <vt:lpstr>Prism Project</vt:lpstr>
      <vt:lpstr>GraphPad Prism 5 Project</vt:lpstr>
      <vt:lpstr>Presentazione standard di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ierdominici Marina</dc:creator>
  <cp:lastModifiedBy>Angela</cp:lastModifiedBy>
  <cp:revision>29</cp:revision>
  <cp:lastPrinted>2015-12-09T10:35:20Z</cp:lastPrinted>
  <dcterms:created xsi:type="dcterms:W3CDTF">2015-12-01T12:04:41Z</dcterms:created>
  <dcterms:modified xsi:type="dcterms:W3CDTF">2015-12-09T13:47:01Z</dcterms:modified>
</cp:coreProperties>
</file>